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300" r:id="rId2"/>
    <p:sldId id="308" r:id="rId3"/>
    <p:sldId id="309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44" userDrawn="1">
          <p15:clr>
            <a:srgbClr val="A4A3A4"/>
          </p15:clr>
        </p15:guide>
        <p15:guide id="3" pos="240" userDrawn="1">
          <p15:clr>
            <a:srgbClr val="A4A3A4"/>
          </p15:clr>
        </p15:guide>
        <p15:guide id="4" pos="3720" userDrawn="1">
          <p15:clr>
            <a:srgbClr val="A4A3A4"/>
          </p15:clr>
        </p15:guide>
        <p15:guide id="6" orient="horz" pos="696" userDrawn="1">
          <p15:clr>
            <a:srgbClr val="A4A3A4"/>
          </p15:clr>
        </p15:guide>
        <p15:guide id="8" pos="2160" userDrawn="1">
          <p15:clr>
            <a:srgbClr val="A4A3A4"/>
          </p15:clr>
        </p15:guide>
        <p15:guide id="9" orient="horz" pos="4728" userDrawn="1">
          <p15:clr>
            <a:srgbClr val="A4A3A4"/>
          </p15:clr>
        </p15:guide>
        <p15:guide id="10" orient="horz" pos="5472" userDrawn="1">
          <p15:clr>
            <a:srgbClr val="A4A3A4"/>
          </p15:clr>
        </p15:guide>
        <p15:guide id="11" pos="4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962DE"/>
    <a:srgbClr val="FE64AB"/>
    <a:srgbClr val="D475FE"/>
    <a:srgbClr val="05ACFC"/>
    <a:srgbClr val="00BE70"/>
    <a:srgbClr val="02C1AB"/>
    <a:srgbClr val="23B700"/>
    <a:srgbClr val="06B6D4"/>
    <a:srgbClr val="8A93FF"/>
    <a:srgbClr val="D1597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042"/>
    <p:restoredTop sz="96281"/>
  </p:normalViewPr>
  <p:slideViewPr>
    <p:cSldViewPr snapToGrid="0" showGuides="1">
      <p:cViewPr varScale="1">
        <p:scale>
          <a:sx n="63" d="100"/>
          <a:sy n="63" d="100"/>
        </p:scale>
        <p:origin x="2165" y="62"/>
      </p:cViewPr>
      <p:guideLst>
        <p:guide orient="horz" pos="2544"/>
        <p:guide pos="240"/>
        <p:guide pos="3720"/>
        <p:guide orient="horz" pos="696"/>
        <p:guide pos="2160"/>
        <p:guide orient="horz" pos="4728"/>
        <p:guide orient="horz" pos="5472"/>
        <p:guide pos="4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9E8A-A72A-E84D-9F27-B58612C1F49C}" type="datetimeFigureOut">
              <a:rPr lang="en-US" smtClean="0"/>
              <a:t>2023-10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1F99E-0613-4E4C-9A18-27AF1D13E0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692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9E8A-A72A-E84D-9F27-B58612C1F49C}" type="datetimeFigureOut">
              <a:rPr lang="en-US" smtClean="0"/>
              <a:t>2023-10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1F99E-0613-4E4C-9A18-27AF1D13E0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248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9E8A-A72A-E84D-9F27-B58612C1F49C}" type="datetimeFigureOut">
              <a:rPr lang="en-US" smtClean="0"/>
              <a:t>2023-10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1F99E-0613-4E4C-9A18-27AF1D13E0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182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9E8A-A72A-E84D-9F27-B58612C1F49C}" type="datetimeFigureOut">
              <a:rPr lang="en-US" smtClean="0"/>
              <a:t>2023-10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1F99E-0613-4E4C-9A18-27AF1D13E0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895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9E8A-A72A-E84D-9F27-B58612C1F49C}" type="datetimeFigureOut">
              <a:rPr lang="en-US" smtClean="0"/>
              <a:t>2023-10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1F99E-0613-4E4C-9A18-27AF1D13E0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9024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9E8A-A72A-E84D-9F27-B58612C1F49C}" type="datetimeFigureOut">
              <a:rPr lang="en-US" smtClean="0"/>
              <a:t>2023-10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1F99E-0613-4E4C-9A18-27AF1D13E0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580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9E8A-A72A-E84D-9F27-B58612C1F49C}" type="datetimeFigureOut">
              <a:rPr lang="en-US" smtClean="0"/>
              <a:t>2023-10-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1F99E-0613-4E4C-9A18-27AF1D13E0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693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9E8A-A72A-E84D-9F27-B58612C1F49C}" type="datetimeFigureOut">
              <a:rPr lang="en-US" smtClean="0"/>
              <a:t>2023-10-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1F99E-0613-4E4C-9A18-27AF1D13E0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748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9E8A-A72A-E84D-9F27-B58612C1F49C}" type="datetimeFigureOut">
              <a:rPr lang="en-US" smtClean="0"/>
              <a:t>2023-10-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1F99E-0613-4E4C-9A18-27AF1D13E0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716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9E8A-A72A-E84D-9F27-B58612C1F49C}" type="datetimeFigureOut">
              <a:rPr lang="en-US" smtClean="0"/>
              <a:t>2023-10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1F99E-0613-4E4C-9A18-27AF1D13E0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80824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309E8A-A72A-E84D-9F27-B58612C1F49C}" type="datetimeFigureOut">
              <a:rPr lang="en-US" smtClean="0"/>
              <a:t>2023-10-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1F99E-0613-4E4C-9A18-27AF1D13E0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6310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309E8A-A72A-E84D-9F27-B58612C1F49C}" type="datetimeFigureOut">
              <a:rPr lang="en-US" smtClean="0"/>
              <a:t>2023-10-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41F99E-0613-4E4C-9A18-27AF1D13E0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208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microsoft.com/office/2007/relationships/hdphoto" Target="../media/hdphoto2.wdp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ti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EEB01D-6282-579D-44C5-1F6A5D3502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8686" y="4936242"/>
            <a:ext cx="5114549" cy="1767417"/>
          </a:xfrm>
        </p:spPr>
        <p:txBody>
          <a:bodyPr anchor="t">
            <a:normAutofit/>
          </a:bodyPr>
          <a:lstStyle/>
          <a:p>
            <a:r>
              <a:rPr lang="en-US" sz="12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Supplementary Figure S1. HK-2 cells cultured in the 2D conditions imaged at different time points as indicated in A-D. </a:t>
            </a:r>
            <a:r>
              <a:rPr lang="en-US" sz="12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M</a:t>
            </a:r>
            <a:r>
              <a:rPr lang="en-US" sz="12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agnification: 20X. </a:t>
            </a:r>
            <a:endParaRPr lang="en-US" sz="14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0" name="Group 59">
            <a:extLst>
              <a:ext uri="{FF2B5EF4-FFF2-40B4-BE49-F238E27FC236}">
                <a16:creationId xmlns:a16="http://schemas.microsoft.com/office/drawing/2014/main" id="{2A50338C-A801-3DF5-3A5E-9697CDAAC0CD}"/>
              </a:ext>
            </a:extLst>
          </p:cNvPr>
          <p:cNvGrpSpPr/>
          <p:nvPr/>
        </p:nvGrpSpPr>
        <p:grpSpPr>
          <a:xfrm>
            <a:off x="968510" y="1111699"/>
            <a:ext cx="4922290" cy="3704164"/>
            <a:chOff x="410787" y="1447800"/>
            <a:chExt cx="4922290" cy="3704164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2370C9C5-0FCB-1CC0-F581-6B50E7793CD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19099" y="1447800"/>
              <a:ext cx="2427545" cy="1828800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2EBC4026-DAF7-5C4B-6331-507ECE0CC51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901027" y="1447800"/>
              <a:ext cx="2427545" cy="1828800"/>
            </a:xfrm>
            <a:prstGeom prst="rect">
              <a:avLst/>
            </a:prstGeom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40DB6A31-E941-E625-66B5-029BBBCB9D5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1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19099" y="3323164"/>
              <a:ext cx="2427545" cy="1828800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0B1DE370-FEC4-457B-932E-D55E95E7176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30000" contrast="1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901027" y="3323164"/>
              <a:ext cx="2427545" cy="1828800"/>
            </a:xfrm>
            <a:prstGeom prst="rect">
              <a:avLst/>
            </a:prstGeom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52C9EC60-A6FB-7E03-C3CF-AD91BB5A700A}"/>
                </a:ext>
              </a:extLst>
            </p:cNvPr>
            <p:cNvSpPr txBox="1"/>
            <p:nvPr/>
          </p:nvSpPr>
          <p:spPr>
            <a:xfrm>
              <a:off x="414595" y="1447800"/>
              <a:ext cx="24275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chemeClr val="bg1"/>
                  </a:solidFill>
                </a:rPr>
                <a:t>A                                   Day 3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EFE5EDE2-EE50-E3AA-B0DD-2BFE7EC5D099}"/>
                </a:ext>
              </a:extLst>
            </p:cNvPr>
            <p:cNvSpPr txBox="1"/>
            <p:nvPr/>
          </p:nvSpPr>
          <p:spPr>
            <a:xfrm>
              <a:off x="2884897" y="1447800"/>
              <a:ext cx="24275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chemeClr val="bg1"/>
                  </a:solidFill>
                </a:rPr>
                <a:t>B                                   Day 5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F5ABF6C2-B923-F742-7676-5A199726D680}"/>
                </a:ext>
              </a:extLst>
            </p:cNvPr>
            <p:cNvSpPr txBox="1"/>
            <p:nvPr/>
          </p:nvSpPr>
          <p:spPr>
            <a:xfrm>
              <a:off x="410787" y="3341272"/>
              <a:ext cx="24275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chemeClr val="bg1"/>
                  </a:solidFill>
                </a:rPr>
                <a:t>C                                   Day 7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FD82D5AD-2E6C-F700-AE05-463713F7325F}"/>
                </a:ext>
              </a:extLst>
            </p:cNvPr>
            <p:cNvSpPr txBox="1"/>
            <p:nvPr/>
          </p:nvSpPr>
          <p:spPr>
            <a:xfrm>
              <a:off x="2905531" y="3329390"/>
              <a:ext cx="242754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chemeClr val="bg1"/>
                  </a:solidFill>
                </a:rPr>
                <a:t>D                                 Day 1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258985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F2E714E7-4697-BB57-926C-25264C7589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1000" y="7424710"/>
            <a:ext cx="5915025" cy="1767417"/>
          </a:xfrm>
        </p:spPr>
        <p:txBody>
          <a:bodyPr anchor="t">
            <a:normAutofit/>
          </a:bodyPr>
          <a:lstStyle/>
          <a:p>
            <a:r>
              <a:rPr lang="en-US" sz="12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Supplementary Figure S2. Pairwise </a:t>
            </a:r>
            <a:r>
              <a:rPr lang="en-US" sz="1200" kern="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Peason</a:t>
            </a:r>
            <a:r>
              <a:rPr lang="en-US" sz="12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 correlation coefficient between 2D, 3D HK-2 cells and native human PTCs in genes sets of PTC selective markers (A), transporters (B), and Drug-metabolizing enzymes (C).</a:t>
            </a:r>
            <a:br>
              <a:rPr lang="en-US" sz="14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r>
              <a:rPr lang="en-US" sz="14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   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2085875-3B41-60C3-C169-B874815228A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0838"/>
          <a:stretch/>
        </p:blipFill>
        <p:spPr>
          <a:xfrm>
            <a:off x="305845" y="4623027"/>
            <a:ext cx="3383280" cy="2262453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id="{9C51035E-407B-83C5-5E49-3E8F66E879D1}"/>
              </a:ext>
            </a:extLst>
          </p:cNvPr>
          <p:cNvGrpSpPr/>
          <p:nvPr/>
        </p:nvGrpSpPr>
        <p:grpSpPr>
          <a:xfrm>
            <a:off x="177449" y="1022205"/>
            <a:ext cx="6510996" cy="3052923"/>
            <a:chOff x="232534" y="1022205"/>
            <a:chExt cx="6510996" cy="3052923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C0EB6B29-7561-43FE-FCC3-2169AFC279B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32534" y="1114759"/>
              <a:ext cx="3383280" cy="2960369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4F8DF389-4B7E-17ED-64A4-92521015733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360250" y="1110184"/>
              <a:ext cx="3383280" cy="2960375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DB3CC3C-E87E-F667-5CBB-3554B5D12503}"/>
                </a:ext>
              </a:extLst>
            </p:cNvPr>
            <p:cNvSpPr txBox="1"/>
            <p:nvPr/>
          </p:nvSpPr>
          <p:spPr>
            <a:xfrm>
              <a:off x="343610" y="1022205"/>
              <a:ext cx="21002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. PTC selective marker genes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A215673-962D-5AAC-7F4C-617F24BEBAE8}"/>
                </a:ext>
              </a:extLst>
            </p:cNvPr>
            <p:cNvSpPr txBox="1"/>
            <p:nvPr/>
          </p:nvSpPr>
          <p:spPr>
            <a:xfrm>
              <a:off x="3449039" y="1022205"/>
              <a:ext cx="23498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. SLC and ABC transporter genes</a:t>
              </a: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8E8B5900-91EA-4E70-1FD3-920171DEE79F}"/>
              </a:ext>
            </a:extLst>
          </p:cNvPr>
          <p:cNvSpPr txBox="1"/>
          <p:nvPr/>
        </p:nvSpPr>
        <p:spPr>
          <a:xfrm>
            <a:off x="302744" y="4205257"/>
            <a:ext cx="21178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Drug-metabolizing enzymes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189F2754-92D6-6B77-C6B4-D00AAB385C6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82572"/>
          <a:stretch/>
        </p:blipFill>
        <p:spPr>
          <a:xfrm>
            <a:off x="188466" y="6848879"/>
            <a:ext cx="3383280" cy="5159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46129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46AB4D20-762D-CF83-8F48-0296FF5CFA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32413" y="486837"/>
            <a:ext cx="5915025" cy="447442"/>
          </a:xfrm>
        </p:spPr>
        <p:txBody>
          <a:bodyPr anchor="t">
            <a:normAutofit/>
          </a:bodyPr>
          <a:lstStyle/>
          <a:p>
            <a:r>
              <a:rPr lang="en-US" sz="12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Supplementary Table S1. Comparison of gene expression levels (fold changes and p values) between the 2D and 3D groups from RT-qPCR results</a:t>
            </a:r>
            <a:endParaRPr lang="en-US" sz="14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6">
            <a:extLst>
              <a:ext uri="{FF2B5EF4-FFF2-40B4-BE49-F238E27FC236}">
                <a16:creationId xmlns:a16="http://schemas.microsoft.com/office/drawing/2014/main" id="{BC6C972D-9BB7-3B6E-0835-4B889532AF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0923744"/>
              </p:ext>
            </p:extLst>
          </p:nvPr>
        </p:nvGraphicFramePr>
        <p:xfrm>
          <a:off x="412534" y="984403"/>
          <a:ext cx="6044590" cy="5166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08918">
                  <a:extLst>
                    <a:ext uri="{9D8B030D-6E8A-4147-A177-3AD203B41FA5}">
                      <a16:colId xmlns:a16="http://schemas.microsoft.com/office/drawing/2014/main" val="311883555"/>
                    </a:ext>
                  </a:extLst>
                </a:gridCol>
                <a:gridCol w="1208918">
                  <a:extLst>
                    <a:ext uri="{9D8B030D-6E8A-4147-A177-3AD203B41FA5}">
                      <a16:colId xmlns:a16="http://schemas.microsoft.com/office/drawing/2014/main" val="98623913"/>
                    </a:ext>
                  </a:extLst>
                </a:gridCol>
                <a:gridCol w="1208918">
                  <a:extLst>
                    <a:ext uri="{9D8B030D-6E8A-4147-A177-3AD203B41FA5}">
                      <a16:colId xmlns:a16="http://schemas.microsoft.com/office/drawing/2014/main" val="2047795915"/>
                    </a:ext>
                  </a:extLst>
                </a:gridCol>
                <a:gridCol w="1208918">
                  <a:extLst>
                    <a:ext uri="{9D8B030D-6E8A-4147-A177-3AD203B41FA5}">
                      <a16:colId xmlns:a16="http://schemas.microsoft.com/office/drawing/2014/main" val="1166824615"/>
                    </a:ext>
                  </a:extLst>
                </a:gridCol>
                <a:gridCol w="1208918">
                  <a:extLst>
                    <a:ext uri="{9D8B030D-6E8A-4147-A177-3AD203B41FA5}">
                      <a16:colId xmlns:a16="http://schemas.microsoft.com/office/drawing/2014/main" val="4243544106"/>
                    </a:ext>
                  </a:extLst>
                </a:gridCol>
              </a:tblGrid>
              <a:tr h="44865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chemeClr val="bg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Gene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ean FC</a:t>
                      </a:r>
                    </a:p>
                    <a:p>
                      <a:pPr algn="ctr"/>
                      <a:r>
                        <a:rPr lang="en-US" sz="1200" b="0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3D/2D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FC of peak level (3D/2D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chemeClr val="bg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487786817"/>
                  </a:ext>
                </a:extLst>
              </a:tr>
              <a:tr h="3363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OAT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7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80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</a:rPr>
                        <a:t>8.6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349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96618185"/>
                  </a:ext>
                </a:extLst>
              </a:tr>
              <a:tr h="3363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OAT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5.0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50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</a:rPr>
                        <a:t>6.0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156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38524032"/>
                  </a:ext>
                </a:extLst>
              </a:tr>
              <a:tr h="3363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OCT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6.3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36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</a:rPr>
                        <a:t>7.6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89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48860613"/>
                  </a:ext>
                </a:extLst>
              </a:tr>
              <a:tr h="3363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OCT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3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46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2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17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27215680"/>
                  </a:ext>
                </a:extLst>
              </a:tr>
              <a:tr h="3363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ATE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7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65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6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41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99924953"/>
                  </a:ext>
                </a:extLst>
              </a:tr>
              <a:tr h="3363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ATE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.3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62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</a:rPr>
                        <a:t>2.4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722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59242702"/>
                  </a:ext>
                </a:extLst>
              </a:tr>
              <a:tr h="3363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RP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4.7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13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</a:rPr>
                        <a:t>45.1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133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59161464"/>
                  </a:ext>
                </a:extLst>
              </a:tr>
              <a:tr h="3363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RP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7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52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8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944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92226349"/>
                  </a:ext>
                </a:extLst>
              </a:tr>
              <a:tr h="3363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DR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17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Palatino Linotype" panose="02040502050505030304" pitchFamily="18" charset="0"/>
                        </a:rPr>
                        <a:t>0.3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25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17069396"/>
                  </a:ext>
                </a:extLst>
              </a:tr>
              <a:tr h="3363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OAT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5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90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Palatino Linotype" panose="02040502050505030304" pitchFamily="18" charset="0"/>
                        </a:rPr>
                        <a:t>0.5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878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03624459"/>
                  </a:ext>
                </a:extLst>
              </a:tr>
              <a:tr h="3363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RP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8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22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.0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385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4737817"/>
                  </a:ext>
                </a:extLst>
              </a:tr>
              <a:tr h="3363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GLT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.9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54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.4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261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83748921"/>
                  </a:ext>
                </a:extLst>
              </a:tr>
              <a:tr h="3363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GLT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.8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37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</a:rPr>
                        <a:t>3.6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233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46499403"/>
                  </a:ext>
                </a:extLst>
              </a:tr>
              <a:tr h="3363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egalin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9.5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1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</a:rPr>
                        <a:t>10.8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C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207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660297454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24781C7E-6932-19AD-2CCF-6054E2ECFDDD}"/>
              </a:ext>
            </a:extLst>
          </p:cNvPr>
          <p:cNvSpPr txBox="1"/>
          <p:nvPr/>
        </p:nvSpPr>
        <p:spPr>
          <a:xfrm>
            <a:off x="432412" y="6160122"/>
            <a:ext cx="602471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Note: </a:t>
            </a:r>
            <a:r>
              <a:rPr lang="en-US" sz="11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Fold change &gt;1.5 were labeled in red, as well as p</a:t>
            </a:r>
            <a:r>
              <a:rPr lang="en-US" sz="1100" i="1" kern="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r>
              <a:rPr lang="en-US" sz="11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value &lt;0.05. Fold change &lt; 0.67 were labeled in blue.  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642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1808</TotalTime>
  <Words>236</Words>
  <Application>Microsoft Office PowerPoint</Application>
  <PresentationFormat>Letter Paper (8.5x11 in)</PresentationFormat>
  <Paragraphs>8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Times New Roman</vt:lpstr>
      <vt:lpstr>Office Theme</vt:lpstr>
      <vt:lpstr>Supplementary Figure S1. HK-2 cells cultured in the 2D conditions imaged at different time points as indicated in A-D. Magnification: 20X. </vt:lpstr>
      <vt:lpstr>Supplementary Figure S2. Pairwise Peason correlation coefficient between 2D, 3D HK-2 cells and native human PTCs in genes sets of PTC selective markers (A), transporters (B), and Drug-metabolizing enzymes (C).     </vt:lpstr>
      <vt:lpstr>Supplementary Table S1. Comparison of gene expression levels (fold changes and p values) between the 2D and 3D groups from RT-qPCR result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1A Cell viability assay</dc:title>
  <dc:creator>Microsoft Office User</dc:creator>
  <cp:lastModifiedBy>MDPI</cp:lastModifiedBy>
  <cp:revision>199</cp:revision>
  <dcterms:created xsi:type="dcterms:W3CDTF">2023-05-04T07:25:06Z</dcterms:created>
  <dcterms:modified xsi:type="dcterms:W3CDTF">2023-10-24T15:40:47Z</dcterms:modified>
</cp:coreProperties>
</file>